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00"/>
    <p:restoredTop sz="94653"/>
  </p:normalViewPr>
  <p:slideViewPr>
    <p:cSldViewPr snapToGrid="0" snapToObjects="1">
      <p:cViewPr varScale="1">
        <p:scale>
          <a:sx n="80" d="100"/>
          <a:sy n="80" d="100"/>
        </p:scale>
        <p:origin x="704" y="1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5DB5EE8-B4EE-D541-8680-873BF51DFC85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B1855F1D-1F0E-7644-AE52-81660CACE88C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26554DB-60F5-7A4C-B1BF-4C4B6AFC553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E0781B-81D9-1342-AF0C-0DC14B7A8519}" type="datetimeFigureOut">
              <a:rPr lang="en-US" smtClean="0"/>
              <a:t>8/2/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1E0509B-68B0-5342-A3E8-EE65718BFEC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BACE8BC-2B5B-9A40-86AF-E03D393F6AA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E7D1FA-7FBF-754A-9E39-354B0CA1190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8534844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B1C04E6-B331-4B49-9FAE-B837B20750D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A21FC5E0-A2BE-324A-A2C8-3765B18CDFB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9CBA776-44D7-5444-B25C-743511F6248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E0781B-81D9-1342-AF0C-0DC14B7A8519}" type="datetimeFigureOut">
              <a:rPr lang="en-US" smtClean="0"/>
              <a:t>8/2/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286C211-5CA1-7745-90C4-1748CDFD57B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CA8D177-A8AF-604D-BA81-1637011BE2E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E7D1FA-7FBF-754A-9E39-354B0CA1190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9010425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C5F33B5A-A0F8-E34F-ADCE-055176FB2FD5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DD53DFDE-5F7A-C64A-8453-15E93D80F97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BF28023-3123-8641-8584-BBFAC2514A3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E0781B-81D9-1342-AF0C-0DC14B7A8519}" type="datetimeFigureOut">
              <a:rPr lang="en-US" smtClean="0"/>
              <a:t>8/2/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A5BFA9D-FC11-164F-85B3-18F631486F3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40C7874-4BB7-3246-A6EA-D36F4B9C543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E7D1FA-7FBF-754A-9E39-354B0CA1190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7595043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2F05465-A2A5-DC4B-B048-DC7981DE9E9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E445BD8-0751-6C46-B0F5-1C84C3BADB1A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B3F123E-3F73-6F43-8488-5E91153D8C7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E0781B-81D9-1342-AF0C-0DC14B7A8519}" type="datetimeFigureOut">
              <a:rPr lang="en-US" smtClean="0"/>
              <a:t>8/2/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478420E-4338-E84E-A754-0CB5F03462B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002DF03-FAB9-7C4F-AB8D-413A9ED0079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E7D1FA-7FBF-754A-9E39-354B0CA1190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0443105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CB7C90C-81AA-DD49-BCA2-977EBD6A877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1E0A8E75-0841-A144-8C3B-0E2D682A9B5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3A81F20-152F-AE40-9989-5EFB95CB4ED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E0781B-81D9-1342-AF0C-0DC14B7A8519}" type="datetimeFigureOut">
              <a:rPr lang="en-US" smtClean="0"/>
              <a:t>8/2/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47FC8DC-AA7B-9847-AF7F-8140EA95FA4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FBAA5DE-4748-F743-9FB3-00CECBB15B2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E7D1FA-7FBF-754A-9E39-354B0CA1190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8378623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AF837F2-D988-404B-9FC0-9425D42E2E7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41A43FDE-C261-3941-9F48-C711B0FA3A34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FC0185EE-A775-224A-95AD-34C7EF478C0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46149C59-7DCE-2942-94AC-FAA9A611093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E0781B-81D9-1342-AF0C-0DC14B7A8519}" type="datetimeFigureOut">
              <a:rPr lang="en-US" smtClean="0"/>
              <a:t>8/2/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E9E1553-D843-4E4F-B2A0-193FCF3CE74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A3E8BFE1-1FED-664F-AD21-BB915AE275B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E7D1FA-7FBF-754A-9E39-354B0CA1190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554841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93BDE48-C0E3-974E-AD97-39C58DAE5F8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1CE00CB7-E970-DD41-968B-D32F7604918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2746A179-9012-A241-B7BA-72917D65879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8ECA0534-D111-8547-B852-4D5210A26DA6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86511A37-E3F5-A145-A9B9-F84D88FDC803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0AB4322F-171A-9843-A978-9549810E216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E0781B-81D9-1342-AF0C-0DC14B7A8519}" type="datetimeFigureOut">
              <a:rPr lang="en-US" smtClean="0"/>
              <a:t>8/2/21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6EACD015-B49B-9A42-9775-DBB22C660B6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0C12EBBB-BAC9-1540-9874-7F6D90D31C0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E7D1FA-7FBF-754A-9E39-354B0CA1190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4805039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28F80FB-26DD-9C4B-9BAB-0F488346141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00DB3801-CDCA-0446-9409-F558AD59004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E0781B-81D9-1342-AF0C-0DC14B7A8519}" type="datetimeFigureOut">
              <a:rPr lang="en-US" smtClean="0"/>
              <a:t>8/2/21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36F3C539-110E-1B43-BA14-18004305845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558C0047-C61A-4B4D-A648-7B08F8AF189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E7D1FA-7FBF-754A-9E39-354B0CA1190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5714192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773413BF-68A0-0E47-9307-C6804DD6E07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E0781B-81D9-1342-AF0C-0DC14B7A8519}" type="datetimeFigureOut">
              <a:rPr lang="en-US" smtClean="0"/>
              <a:t>8/2/21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B5DA7243-DC2F-DD4A-8087-862961161D6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41F9DA64-0BF4-5844-90D7-6F018F3C310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E7D1FA-7FBF-754A-9E39-354B0CA1190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8986582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37922C4-5504-6941-A6DE-F044FB1D0C6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6740D74-AAA2-204C-B6FD-424E0CD713B7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996532D4-5235-C145-85B1-A96304A40D2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78B6DA31-FB48-6146-B8D7-CD4A73B1EE6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E0781B-81D9-1342-AF0C-0DC14B7A8519}" type="datetimeFigureOut">
              <a:rPr lang="en-US" smtClean="0"/>
              <a:t>8/2/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28AB7432-0C22-B949-94C9-26BAD0E80FC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00D65322-906D-9E4C-A889-336717B8A00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E7D1FA-7FBF-754A-9E39-354B0CA1190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3861198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FD37EF3-2B6F-5346-88AA-C4F5D229510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0E238F26-C7F4-4444-87AE-E1C10C70CCDA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3EB98DF0-863D-924A-9CE9-6117D4F6352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2F80D16E-F4CB-7B44-9374-069139ADD20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E0781B-81D9-1342-AF0C-0DC14B7A8519}" type="datetimeFigureOut">
              <a:rPr lang="en-US" smtClean="0"/>
              <a:t>8/2/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5CF0FAAD-189F-734E-974A-07A82682F4B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0513CBF5-578F-2741-8B0A-87984AB3BEC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E7D1FA-7FBF-754A-9E39-354B0CA1190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4318776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30AEC63D-3187-2547-A77D-37D61E55532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35C30159-AC60-8241-AE6C-88113885485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DC4FADD-DAF5-104C-BBBD-7AC10C2E58FB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6E0781B-81D9-1342-AF0C-0DC14B7A8519}" type="datetimeFigureOut">
              <a:rPr lang="en-US" smtClean="0"/>
              <a:t>8/2/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47B1B63-BED1-7447-B7A2-7BB7A5F46D34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1E63D9D-18A6-BA42-9C4A-408D946ACE97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4E7D1FA-7FBF-754A-9E39-354B0CA1190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2005023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C37C7257-B801-4C4A-B4A8-B4D67EA78B32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748590" y="288756"/>
            <a:ext cx="4103671" cy="3107490"/>
          </a:xfrm>
          <a:prstGeom prst="rect">
            <a:avLst/>
          </a:prstGeom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92094030-F54C-E148-80AC-ED9F95E1F3E0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852261" y="288756"/>
            <a:ext cx="4168041" cy="3107490"/>
          </a:xfrm>
          <a:prstGeom prst="rect">
            <a:avLst/>
          </a:prstGeom>
        </p:spPr>
      </p:pic>
      <p:pic>
        <p:nvPicPr>
          <p:cNvPr id="9" name="Picture 8">
            <a:extLst>
              <a:ext uri="{FF2B5EF4-FFF2-40B4-BE49-F238E27FC236}">
                <a16:creationId xmlns:a16="http://schemas.microsoft.com/office/drawing/2014/main" id="{C4DA2304-C870-1043-B26C-5AE11AF100ED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748590" y="3396246"/>
            <a:ext cx="4283242" cy="3065713"/>
          </a:xfrm>
          <a:prstGeom prst="rect">
            <a:avLst/>
          </a:prstGeom>
        </p:spPr>
      </p:pic>
      <p:pic>
        <p:nvPicPr>
          <p:cNvPr id="11" name="Picture 10">
            <a:extLst>
              <a:ext uri="{FF2B5EF4-FFF2-40B4-BE49-F238E27FC236}">
                <a16:creationId xmlns:a16="http://schemas.microsoft.com/office/drawing/2014/main" id="{6BF6E10A-13BA-CC4A-9F9D-C8F738C7CE49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5952500" y="3256546"/>
            <a:ext cx="4067802" cy="3205414"/>
          </a:xfrm>
          <a:prstGeom prst="rect">
            <a:avLst/>
          </a:prstGeom>
        </p:spPr>
      </p:pic>
      <p:sp>
        <p:nvSpPr>
          <p:cNvPr id="12" name="Rectangle 11">
            <a:extLst>
              <a:ext uri="{FF2B5EF4-FFF2-40B4-BE49-F238E27FC236}">
                <a16:creationId xmlns:a16="http://schemas.microsoft.com/office/drawing/2014/main" id="{A73D0DB4-C3E2-E24A-BE1B-F2BCD976CF23}"/>
              </a:ext>
            </a:extLst>
          </p:cNvPr>
          <p:cNvSpPr/>
          <p:nvPr/>
        </p:nvSpPr>
        <p:spPr>
          <a:xfrm>
            <a:off x="1748589" y="288756"/>
            <a:ext cx="4103671" cy="336884"/>
          </a:xfrm>
          <a:prstGeom prst="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200" dirty="0"/>
              <a:t>A: ROX index prior to HFNC initiation among pneumonia patients</a:t>
            </a:r>
          </a:p>
        </p:txBody>
      </p:sp>
      <p:sp>
        <p:nvSpPr>
          <p:cNvPr id="13" name="Rectangle 12">
            <a:extLst>
              <a:ext uri="{FF2B5EF4-FFF2-40B4-BE49-F238E27FC236}">
                <a16:creationId xmlns:a16="http://schemas.microsoft.com/office/drawing/2014/main" id="{6F422B42-B3F8-4747-89A6-BFA4A3F4439F}"/>
              </a:ext>
            </a:extLst>
          </p:cNvPr>
          <p:cNvSpPr/>
          <p:nvPr/>
        </p:nvSpPr>
        <p:spPr>
          <a:xfrm>
            <a:off x="1748590" y="3380204"/>
            <a:ext cx="4103671" cy="336884"/>
          </a:xfrm>
          <a:prstGeom prst="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200" dirty="0"/>
              <a:t>C: ROX index prior to HFNC initiation among non-pneumonia patients</a:t>
            </a:r>
          </a:p>
        </p:txBody>
      </p:sp>
      <p:sp>
        <p:nvSpPr>
          <p:cNvPr id="14" name="Rectangle 13">
            <a:extLst>
              <a:ext uri="{FF2B5EF4-FFF2-40B4-BE49-F238E27FC236}">
                <a16:creationId xmlns:a16="http://schemas.microsoft.com/office/drawing/2014/main" id="{0DBD3F3C-7767-904D-9CAB-247D07DF8E31}"/>
              </a:ext>
            </a:extLst>
          </p:cNvPr>
          <p:cNvSpPr/>
          <p:nvPr/>
        </p:nvSpPr>
        <p:spPr>
          <a:xfrm>
            <a:off x="5934565" y="288755"/>
            <a:ext cx="4103671" cy="336884"/>
          </a:xfrm>
          <a:prstGeom prst="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200" dirty="0"/>
              <a:t>B: ROX index one—hour post-HFNC initiation among pneumonia patients</a:t>
            </a:r>
          </a:p>
        </p:txBody>
      </p:sp>
      <p:sp>
        <p:nvSpPr>
          <p:cNvPr id="15" name="Rectangle 14">
            <a:extLst>
              <a:ext uri="{FF2B5EF4-FFF2-40B4-BE49-F238E27FC236}">
                <a16:creationId xmlns:a16="http://schemas.microsoft.com/office/drawing/2014/main" id="{B43E8B45-9FEA-904C-A1EC-0A12B04EFAFA}"/>
              </a:ext>
            </a:extLst>
          </p:cNvPr>
          <p:cNvSpPr/>
          <p:nvPr/>
        </p:nvSpPr>
        <p:spPr>
          <a:xfrm>
            <a:off x="6011669" y="3367504"/>
            <a:ext cx="4103671" cy="336884"/>
          </a:xfrm>
          <a:prstGeom prst="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200" dirty="0"/>
              <a:t>D: ROX index one—hour post-HFNC initiation among non-pneumonia patients</a:t>
            </a:r>
          </a:p>
        </p:txBody>
      </p:sp>
    </p:spTree>
    <p:extLst>
      <p:ext uri="{BB962C8B-B14F-4D97-AF65-F5344CB8AC3E}">
        <p14:creationId xmlns:p14="http://schemas.microsoft.com/office/powerpoint/2010/main" val="180053670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5</TotalTime>
  <Words>46</Words>
  <Application>Microsoft Macintosh PowerPoint</Application>
  <PresentationFormat>Widescreen</PresentationFormat>
  <Paragraphs>4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16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icrosoft Office User</dc:creator>
  <cp:lastModifiedBy>Microsoft Office User</cp:lastModifiedBy>
  <cp:revision>2</cp:revision>
  <dcterms:created xsi:type="dcterms:W3CDTF">2021-08-02T03:28:48Z</dcterms:created>
  <dcterms:modified xsi:type="dcterms:W3CDTF">2021-08-02T03:34:14Z</dcterms:modified>
</cp:coreProperties>
</file>